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sldIdLst>
    <p:sldId id="262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7"/>
    <p:restoredTop sz="96154"/>
  </p:normalViewPr>
  <p:slideViewPr>
    <p:cSldViewPr snapToGrid="0">
      <p:cViewPr varScale="1">
        <p:scale>
          <a:sx n="66" d="100"/>
          <a:sy n="66" d="100"/>
        </p:scale>
        <p:origin x="3576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61FE5-83C1-CB4D-8B24-7544267C4674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70414-20AE-EB48-98CA-14828549534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61FE5-83C1-CB4D-8B24-7544267C4674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70414-20AE-EB48-98CA-14828549534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61FE5-83C1-CB4D-8B24-7544267C4674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70414-20AE-EB48-98CA-14828549534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61FE5-83C1-CB4D-8B24-7544267C4674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70414-20AE-EB48-98CA-14828549534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61FE5-83C1-CB4D-8B24-7544267C4674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70414-20AE-EB48-98CA-14828549534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61FE5-83C1-CB4D-8B24-7544267C4674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70414-20AE-EB48-98CA-14828549534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61FE5-83C1-CB4D-8B24-7544267C4674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70414-20AE-EB48-98CA-14828549534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61FE5-83C1-CB4D-8B24-7544267C4674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70414-20AE-EB48-98CA-14828549534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61FE5-83C1-CB4D-8B24-7544267C4674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70414-20AE-EB48-98CA-14828549534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61FE5-83C1-CB4D-8B24-7544267C4674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70414-20AE-EB48-98CA-14828549534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61FE5-83C1-CB4D-8B24-7544267C4674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70414-20AE-EB48-98CA-14828549534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B61FE5-83C1-CB4D-8B24-7544267C4674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D70414-20AE-EB48-98CA-148285495340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/>
          <p:cNvGraphicFramePr>
            <a:graphicFrameLocks noGrp="1"/>
          </p:cNvGraphicFramePr>
          <p:nvPr/>
        </p:nvGraphicFramePr>
        <p:xfrm>
          <a:off x="111869" y="3171218"/>
          <a:ext cx="6634263" cy="200743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754876"/>
                <a:gridCol w="2879387"/>
              </a:tblGrid>
              <a:tr h="648114">
                <a:tc>
                  <a:txBody>
                    <a:bodyPr/>
                    <a:lstStyle/>
                    <a:p>
                      <a:r>
                        <a:rPr lang="en-US" sz="1800" dirty="0" err="1"/>
                        <a:t>Chr:Pos:REF:ALT</a:t>
                      </a:r>
                      <a:endParaRPr lang="en-US" sz="1800" dirty="0"/>
                    </a:p>
                  </a:txBody>
                  <a:tcPr marL="162560" marR="162560" marT="81282" marB="81282"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Description</a:t>
                      </a:r>
                      <a:endParaRPr lang="en-US" sz="1800" dirty="0"/>
                    </a:p>
                  </a:txBody>
                  <a:tcPr marL="162560" marR="162560" marT="81282" marB="81282"/>
                </a:tc>
              </a:tr>
              <a:tr h="711204">
                <a:tc>
                  <a:txBody>
                    <a:bodyPr/>
                    <a:lstStyle/>
                    <a:p>
                      <a:r>
                        <a:rPr lang="en-US" sz="1800" dirty="0"/>
                        <a:t>18:59992619::TCGCGCTGCTGCTGCTCTGCGCGCTGC</a:t>
                      </a:r>
                      <a:endParaRPr lang="en-US" sz="1800" dirty="0"/>
                    </a:p>
                  </a:txBody>
                  <a:tcPr marL="162560" marR="162560" marT="81282" marB="81282"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Insertion of CTG motif </a:t>
                      </a:r>
                      <a:endParaRPr lang="en-US" sz="1800" dirty="0"/>
                    </a:p>
                  </a:txBody>
                  <a:tcPr marL="162560" marR="162560" marT="81282" marB="81282"/>
                </a:tc>
              </a:tr>
              <a:tr h="648114">
                <a:tc>
                  <a:txBody>
                    <a:bodyPr/>
                    <a:lstStyle/>
                    <a:p>
                      <a:r>
                        <a:rPr lang="en-US" sz="1800" dirty="0"/>
                        <a:t>16:56388929:ATT:</a:t>
                      </a:r>
                      <a:endParaRPr lang="en-US" sz="1800" dirty="0"/>
                    </a:p>
                  </a:txBody>
                  <a:tcPr marL="162560" marR="162560" marT="81282" marB="81282"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Short 1 codon deletion</a:t>
                      </a:r>
                      <a:endParaRPr lang="en-US" sz="1800" dirty="0"/>
                    </a:p>
                  </a:txBody>
                  <a:tcPr marL="162560" marR="162560" marT="81282" marB="81282"/>
                </a:tc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267335" y="2513965"/>
            <a:ext cx="64789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Table S1: Common false positives given by MetaRNN</a:t>
            </a:r>
            <a:endParaRPr lang="en-US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76</Words>
  <Application>WPS Presentation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SimSun</vt:lpstr>
      <vt:lpstr>Wingdings</vt:lpstr>
      <vt:lpstr>Calibri</vt:lpstr>
      <vt:lpstr>Microsoft YaHei</vt:lpstr>
      <vt:lpstr>Arial Unicode MS</vt:lpstr>
      <vt:lpstr>Calibri Light</vt:lpstr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E Rauch</dc:creator>
  <cp:lastModifiedBy>Moni isaac</cp:lastModifiedBy>
  <cp:revision>3</cp:revision>
  <dcterms:created xsi:type="dcterms:W3CDTF">2025-06-18T20:43:00Z</dcterms:created>
  <dcterms:modified xsi:type="dcterms:W3CDTF">2025-07-14T01:18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FF9BC41C46614831AD7F7D7F534FBD78_12</vt:lpwstr>
  </property>
  <property fmtid="{D5CDD505-2E9C-101B-9397-08002B2CF9AE}" pid="3" name="KSOProductBuildVer">
    <vt:lpwstr>1033-12.2.0.21931</vt:lpwstr>
  </property>
</Properties>
</file>